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359" r:id="rId2"/>
  </p:sldIdLst>
  <p:sldSz cx="12192000" cy="6858000"/>
  <p:notesSz cx="9923463" cy="67945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3840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Scientific Editor" initials="SE" lastIdx="9" clrIdx="0">
    <p:extLst>
      <p:ext uri="{19B8F6BF-5375-455C-9EA6-DF929625EA0E}">
        <p15:presenceInfo xmlns:p15="http://schemas.microsoft.com/office/powerpoint/2012/main" userId="Scientific Editor" providerId="None"/>
      </p:ext>
    </p:extLst>
  </p:cmAuthor>
  <p:cmAuthor id="2" name="takesue" initials="t" lastIdx="5" clrIdx="1">
    <p:extLst>
      <p:ext uri="{19B8F6BF-5375-455C-9EA6-DF929625EA0E}">
        <p15:presenceInfo xmlns:p15="http://schemas.microsoft.com/office/powerpoint/2012/main" userId="takesue" providerId="Non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616DA210-FB5B-4158-B5E0-FEB733F419BA}" styleName="スタイル (淡色) 3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254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  <a:tblStyle styleId="{5940675A-B579-460E-94D1-54222C63F5DA}" styleName="スタイルなし、表のグリッド線あり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6426" autoAdjust="0"/>
    <p:restoredTop sz="95529" autoAdjust="0"/>
  </p:normalViewPr>
  <p:slideViewPr>
    <p:cSldViewPr snapToGrid="0">
      <p:cViewPr varScale="1">
        <p:scale>
          <a:sx n="110" d="100"/>
          <a:sy n="110" d="100"/>
        </p:scale>
        <p:origin x="1044" y="108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commentAuthors" Target="commentAuthor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4300749" cy="341154"/>
          </a:xfrm>
          <a:prstGeom prst="rect">
            <a:avLst/>
          </a:prstGeom>
        </p:spPr>
        <p:txBody>
          <a:bodyPr vert="horz" lIns="91403" tIns="45702" rIns="91403" bIns="45702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5621127" y="0"/>
            <a:ext cx="4300749" cy="341154"/>
          </a:xfrm>
          <a:prstGeom prst="rect">
            <a:avLst/>
          </a:prstGeom>
        </p:spPr>
        <p:txBody>
          <a:bodyPr vert="horz" lIns="91403" tIns="45702" rIns="91403" bIns="45702" rtlCol="0"/>
          <a:lstStyle>
            <a:lvl1pPr algn="r">
              <a:defRPr sz="1200"/>
            </a:lvl1pPr>
          </a:lstStyle>
          <a:p>
            <a:fld id="{EE51A95F-65DE-4144-A4F9-634112008E7B}" type="datetimeFigureOut">
              <a:rPr kumimoji="1" lang="ja-JP" altLang="en-US" smtClean="0"/>
              <a:t>2023/4/12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2924175" y="849313"/>
            <a:ext cx="4075113" cy="229235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03" tIns="45702" rIns="91403" bIns="45702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991871" y="3270310"/>
            <a:ext cx="7939722" cy="2675275"/>
          </a:xfrm>
          <a:prstGeom prst="rect">
            <a:avLst/>
          </a:prstGeom>
        </p:spPr>
        <p:txBody>
          <a:bodyPr vert="horz" lIns="91403" tIns="45702" rIns="91403" bIns="45702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6453347"/>
            <a:ext cx="4300749" cy="341153"/>
          </a:xfrm>
          <a:prstGeom prst="rect">
            <a:avLst/>
          </a:prstGeom>
        </p:spPr>
        <p:txBody>
          <a:bodyPr vert="horz" lIns="91403" tIns="45702" rIns="91403" bIns="45702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5621127" y="6453347"/>
            <a:ext cx="4300749" cy="341153"/>
          </a:xfrm>
          <a:prstGeom prst="rect">
            <a:avLst/>
          </a:prstGeom>
        </p:spPr>
        <p:txBody>
          <a:bodyPr vert="horz" lIns="91403" tIns="45702" rIns="91403" bIns="45702" rtlCol="0" anchor="b"/>
          <a:lstStyle>
            <a:lvl1pPr algn="r">
              <a:defRPr sz="1200"/>
            </a:lvl1pPr>
          </a:lstStyle>
          <a:p>
            <a:fld id="{E3776AED-F714-4E36-B15F-2F7F9B335F9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5087958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algn="ctr" defTabSz="914034" fontAlgn="ctr">
              <a:defRPr/>
            </a:pPr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Discontinuation of antibiotics in patients with prolonged use or noninfectious conditions was a leading reason for intervention (55.7%), followed by alteration of antibiotics other than de-escalation or intravenous to oral stepdown (40.1%). The cumulative number of reasons was 344 in 192 events (1.79/event) and the overall adherence rate was 89.0% (306/344).</a:t>
            </a:r>
          </a:p>
          <a:p>
            <a:pPr algn="ctr" fontAlgn="ctr"/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endParaRPr lang="ja-JP" altLang="en-US" dirty="0">
              <a:latin typeface="Times New Roman" panose="02020603050405020304" pitchFamily="18" charset="0"/>
              <a:ea typeface="HG丸ｺﾞｼｯｸM-PRO" panose="020F0600000000000000" pitchFamily="50" charset="-128"/>
              <a:cs typeface="Times New Roman" panose="02020603050405020304" pitchFamily="18" charset="0"/>
            </a:endParaRPr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E3776AED-F714-4E36-B15F-2F7F9B335F94}" type="slidenum">
              <a:rPr kumimoji="1" lang="ja-JP" altLang="en-US" smtClean="0"/>
              <a:t>1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41275674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FB805445-C5E7-8F3D-996C-AD90650695A7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字幕 2">
            <a:extLst>
              <a:ext uri="{FF2B5EF4-FFF2-40B4-BE49-F238E27FC236}">
                <a16:creationId xmlns:a16="http://schemas.microsoft.com/office/drawing/2014/main" id="{4C033B15-A4F8-6D06-28C0-1A2D4026D0FA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0FC87F14-493E-DD58-B161-EC24192C320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59BB2F-FF39-4E29-99C2-7B33A3517908}" type="datetimeFigureOut">
              <a:rPr kumimoji="1" lang="ja-JP" altLang="en-US" smtClean="0"/>
              <a:t>2023/4/12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40D18E99-8411-65B0-2E48-739DF1C670D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C733CEF5-EDC4-F417-EB78-DBB057DCE2A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F355FD-AC4B-44D3-8BA8-93BFA3AE574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0967926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42698543-C304-D1F8-0D6B-FCEE7567498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D3D4BEDC-5958-8A32-4BEA-4DA04809246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C3837EBE-E13E-9DBC-A607-854C2B8E80B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59BB2F-FF39-4E29-99C2-7B33A3517908}" type="datetimeFigureOut">
              <a:rPr kumimoji="1" lang="ja-JP" altLang="en-US" smtClean="0"/>
              <a:t>2023/4/12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8EFEC844-3CE3-9E1D-561F-65256E043EF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964862CB-AE89-F53E-CBE6-C527B6EAF16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F355FD-AC4B-44D3-8BA8-93BFA3AE574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1348626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>
            <a:extLst>
              <a:ext uri="{FF2B5EF4-FFF2-40B4-BE49-F238E27FC236}">
                <a16:creationId xmlns:a16="http://schemas.microsoft.com/office/drawing/2014/main" id="{44F8DADB-12FE-172E-9244-A8BB8E99190B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0AEABBDB-F138-6847-CA5E-7DA0EEDFE66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EBFE7E1F-CA43-EFBF-947E-7C9267F8677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59BB2F-FF39-4E29-99C2-7B33A3517908}" type="datetimeFigureOut">
              <a:rPr kumimoji="1" lang="ja-JP" altLang="en-US" smtClean="0"/>
              <a:t>2023/4/12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F80C432C-E29E-D3B8-AC56-E06F829D81A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3637A043-6A8F-6554-056F-723521569C4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F355FD-AC4B-44D3-8BA8-93BFA3AE574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3417503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B0BDA391-41BC-8784-7F50-698A57A03A0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E3A5739D-C5BA-22E2-8E9D-19F595042A63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9B5F3F2A-9A84-A233-AFFF-DBD8EA2FA7A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59BB2F-FF39-4E29-99C2-7B33A3517908}" type="datetimeFigureOut">
              <a:rPr kumimoji="1" lang="ja-JP" altLang="en-US" smtClean="0"/>
              <a:t>2023/4/12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CBB273A7-8C01-0B32-D927-A54EF518840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A29BCC30-51BC-9E5D-64E0-C4186E67D64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F355FD-AC4B-44D3-8BA8-93BFA3AE574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0117347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023F1CD6-FEC7-E737-0A7C-5654D4C4890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EAD5CB1A-09A0-9161-A4F9-739111FAE1C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DD679982-F495-7293-9420-80801866D51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59BB2F-FF39-4E29-99C2-7B33A3517908}" type="datetimeFigureOut">
              <a:rPr kumimoji="1" lang="ja-JP" altLang="en-US" smtClean="0"/>
              <a:t>2023/4/12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BACDE3FD-03DF-33F6-1DE8-EADC8FA5CEB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A76B58B4-D4A8-D28F-7E00-2CE7DA7DCC9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F355FD-AC4B-44D3-8BA8-93BFA3AE574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3556712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C257BC8D-CC93-E33B-79AE-AE2CAB14D0E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980143E3-8DA8-1924-1FB4-70E81399409F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ECCBCFA5-4794-6D86-5232-F3142F51587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CE349ED8-6BCD-343D-89CE-6CA4BDD8BC0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59BB2F-FF39-4E29-99C2-7B33A3517908}" type="datetimeFigureOut">
              <a:rPr kumimoji="1" lang="ja-JP" altLang="en-US" smtClean="0"/>
              <a:t>2023/4/12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3B295D9E-3042-EBF9-590C-6D15DB1541B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D51B38AD-51DE-5A12-AB13-DA2E1E5A6B7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F355FD-AC4B-44D3-8BA8-93BFA3AE574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1655174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542AD5B5-0AA4-B54A-EDA9-C4F15B3F934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C6A8EF41-E38C-25BA-18EB-2E978FF3E66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6B557007-AEFF-29F5-5185-6F3687C24B1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>
            <a:extLst>
              <a:ext uri="{FF2B5EF4-FFF2-40B4-BE49-F238E27FC236}">
                <a16:creationId xmlns:a16="http://schemas.microsoft.com/office/drawing/2014/main" id="{7DF7C524-F2E7-4F44-4D91-41A1D72A6518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>
            <a:extLst>
              <a:ext uri="{FF2B5EF4-FFF2-40B4-BE49-F238E27FC236}">
                <a16:creationId xmlns:a16="http://schemas.microsoft.com/office/drawing/2014/main" id="{A580C3B5-1FC5-8827-E67A-7137A7D5CFE9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>
            <a:extLst>
              <a:ext uri="{FF2B5EF4-FFF2-40B4-BE49-F238E27FC236}">
                <a16:creationId xmlns:a16="http://schemas.microsoft.com/office/drawing/2014/main" id="{9EBC0B17-37D0-6804-2642-F85E21268B0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59BB2F-FF39-4E29-99C2-7B33A3517908}" type="datetimeFigureOut">
              <a:rPr kumimoji="1" lang="ja-JP" altLang="en-US" smtClean="0"/>
              <a:t>2023/4/12</a:t>
            </a:fld>
            <a:endParaRPr kumimoji="1" lang="ja-JP" altLang="en-US"/>
          </a:p>
        </p:txBody>
      </p:sp>
      <p:sp>
        <p:nvSpPr>
          <p:cNvPr id="8" name="フッター プレースホルダー 7">
            <a:extLst>
              <a:ext uri="{FF2B5EF4-FFF2-40B4-BE49-F238E27FC236}">
                <a16:creationId xmlns:a16="http://schemas.microsoft.com/office/drawing/2014/main" id="{486DB4C3-D99D-66C0-9B9B-7EA3BE89677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>
            <a:extLst>
              <a:ext uri="{FF2B5EF4-FFF2-40B4-BE49-F238E27FC236}">
                <a16:creationId xmlns:a16="http://schemas.microsoft.com/office/drawing/2014/main" id="{10B1387E-978A-9A80-E28C-E0F9DA3FEA9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F355FD-AC4B-44D3-8BA8-93BFA3AE574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5578604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63D41263-06DA-4F04-E1D6-77EDC95136F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id="{ED4832DD-62AD-81AE-42D3-F0B25D39517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59BB2F-FF39-4E29-99C2-7B33A3517908}" type="datetimeFigureOut">
              <a:rPr kumimoji="1" lang="ja-JP" altLang="en-US" smtClean="0"/>
              <a:t>2023/4/12</a:t>
            </a:fld>
            <a:endParaRPr kumimoji="1" lang="ja-JP" altLang="en-US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id="{90E13C27-E914-7074-876C-16E94812D40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id="{8DAA2339-A053-13A5-6AD4-BAABA00700B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F355FD-AC4B-44D3-8BA8-93BFA3AE574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4331876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>
            <a:extLst>
              <a:ext uri="{FF2B5EF4-FFF2-40B4-BE49-F238E27FC236}">
                <a16:creationId xmlns:a16="http://schemas.microsoft.com/office/drawing/2014/main" id="{7D530694-D296-03C8-F4D5-9DE351A6692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59BB2F-FF39-4E29-99C2-7B33A3517908}" type="datetimeFigureOut">
              <a:rPr kumimoji="1" lang="ja-JP" altLang="en-US" smtClean="0"/>
              <a:t>2023/4/12</a:t>
            </a:fld>
            <a:endParaRPr kumimoji="1" lang="ja-JP" altLang="en-US"/>
          </a:p>
        </p:txBody>
      </p:sp>
      <p:sp>
        <p:nvSpPr>
          <p:cNvPr id="3" name="フッター プレースホルダー 2">
            <a:extLst>
              <a:ext uri="{FF2B5EF4-FFF2-40B4-BE49-F238E27FC236}">
                <a16:creationId xmlns:a16="http://schemas.microsoft.com/office/drawing/2014/main" id="{9C64E79D-6A5C-CA72-C94F-A3E2C1A1571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3DC5F7FD-D4BD-6C5B-5194-1AC3EB42B0E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F355FD-AC4B-44D3-8BA8-93BFA3AE574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1275040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1E7B202E-6E1B-BDF9-F7FF-9AA9328D8BE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84529CAD-7770-44A5-00AB-2C3B356EF050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FDD6EE63-BE28-B8D0-57AA-064197EAFF0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6AB4F50D-30FD-EA7E-FAC9-5E56B933B00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59BB2F-FF39-4E29-99C2-7B33A3517908}" type="datetimeFigureOut">
              <a:rPr kumimoji="1" lang="ja-JP" altLang="en-US" smtClean="0"/>
              <a:t>2023/4/12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6FB0D5C2-601D-5FC0-FD06-9A6D0E8EB24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A695EBB8-A87D-5FCB-95D4-897BD1E3136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F355FD-AC4B-44D3-8BA8-93BFA3AE574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8178751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A25901B9-027C-8CF8-B66F-D01D5AE3F89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>
            <a:extLst>
              <a:ext uri="{FF2B5EF4-FFF2-40B4-BE49-F238E27FC236}">
                <a16:creationId xmlns:a16="http://schemas.microsoft.com/office/drawing/2014/main" id="{8A623BA3-F2C7-E504-C748-B839E2523B91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BA07837E-40DB-31B6-5C90-5B263A64C12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D9B9F8B2-5AB9-899D-82E7-2F246515C56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59BB2F-FF39-4E29-99C2-7B33A3517908}" type="datetimeFigureOut">
              <a:rPr kumimoji="1" lang="ja-JP" altLang="en-US" smtClean="0"/>
              <a:t>2023/4/12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A567CE2C-2F2C-11FE-EE36-C155014E750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E35A3879-3D86-6ED3-0BAB-F98B80C0F87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F355FD-AC4B-44D3-8BA8-93BFA3AE574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3554713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>
            <a:extLst>
              <a:ext uri="{FF2B5EF4-FFF2-40B4-BE49-F238E27FC236}">
                <a16:creationId xmlns:a16="http://schemas.microsoft.com/office/drawing/2014/main" id="{BF2BFEDC-5E77-D0D7-D3FE-0DA0E0ECB0F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6756CCB6-60C8-67B7-381C-B0006635C9A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1742A2E9-A0C1-0081-604B-10C2D16DA7B8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159BB2F-FF39-4E29-99C2-7B33A3517908}" type="datetimeFigureOut">
              <a:rPr kumimoji="1" lang="ja-JP" altLang="en-US" smtClean="0"/>
              <a:t>2023/4/12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B7C0A2F7-0AAA-B474-9AF4-84E6FCE3F363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8E183C30-2FBD-BC16-D0CC-FF7480F55EFF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CF355FD-AC4B-44D3-8BA8-93BFA3AE574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9589541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FFADD966-1CB2-40D8-82EF-F50EC891155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1067749" y="812627"/>
            <a:ext cx="10515600" cy="633165"/>
          </a:xfrm>
        </p:spPr>
        <p:txBody>
          <a:bodyPr>
            <a:normAutofit/>
          </a:bodyPr>
          <a:lstStyle/>
          <a:p>
            <a:r>
              <a:rPr kumimoji="1" lang="hu-HU" altLang="ja-JP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</a:t>
            </a:r>
            <a:r>
              <a:rPr kumimoji="1" lang="en-US" altLang="ja-JP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5</a:t>
            </a:r>
            <a:r>
              <a:rPr kumimoji="1" lang="hu-HU" altLang="ja-JP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Table</a:t>
            </a:r>
            <a:r>
              <a:rPr kumimoji="1" lang="en-US" altLang="ja-JP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Reasons for intervention by antimicrobial stewardship team and adherence rate by physicians between April 2022 and September 2022</a:t>
            </a:r>
            <a:r>
              <a:rPr kumimoji="1" lang="hu-HU" altLang="ja-JP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  <a:endParaRPr kumimoji="1" lang="ja-JP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4" name="表 3">
            <a:extLst>
              <a:ext uri="{FF2B5EF4-FFF2-40B4-BE49-F238E27FC236}">
                <a16:creationId xmlns:a16="http://schemas.microsoft.com/office/drawing/2014/main" id="{48AFB052-C807-4E1E-8BDF-824C19D5D59A}"/>
              </a:ext>
            </a:extLst>
          </p:cNvPr>
          <p:cNvGraphicFramePr>
            <a:graphicFrameLocks noGrp="1"/>
          </p:cNvGraphicFramePr>
          <p:nvPr/>
        </p:nvGraphicFramePr>
        <p:xfrm>
          <a:off x="1067749" y="1468073"/>
          <a:ext cx="10342029" cy="4029242"/>
        </p:xfrm>
        <a:graphic>
          <a:graphicData uri="http://schemas.openxmlformats.org/drawingml/2006/table">
            <a:tbl>
              <a:tblPr>
                <a:tableStyleId>{5940675A-B579-460E-94D1-54222C63F5DA}</a:tableStyleId>
              </a:tblPr>
              <a:tblGrid>
                <a:gridCol w="4738245">
                  <a:extLst>
                    <a:ext uri="{9D8B030D-6E8A-4147-A177-3AD203B41FA5}">
                      <a16:colId xmlns:a16="http://schemas.microsoft.com/office/drawing/2014/main" val="2089167139"/>
                    </a:ext>
                  </a:extLst>
                </a:gridCol>
                <a:gridCol w="3099678">
                  <a:extLst>
                    <a:ext uri="{9D8B030D-6E8A-4147-A177-3AD203B41FA5}">
                      <a16:colId xmlns:a16="http://schemas.microsoft.com/office/drawing/2014/main" val="383755412"/>
                    </a:ext>
                  </a:extLst>
                </a:gridCol>
                <a:gridCol w="2504106">
                  <a:extLst>
                    <a:ext uri="{9D8B030D-6E8A-4147-A177-3AD203B41FA5}">
                      <a16:colId xmlns:a16="http://schemas.microsoft.com/office/drawing/2014/main" val="3053894586"/>
                    </a:ext>
                  </a:extLst>
                </a:gridCol>
              </a:tblGrid>
              <a:tr h="523978">
                <a:tc>
                  <a:txBody>
                    <a:bodyPr/>
                    <a:lstStyle/>
                    <a:p>
                      <a:pPr algn="ctr" fontAlgn="ctr"/>
                      <a:r>
                        <a:rPr kumimoji="1" lang="en-US" altLang="ja-JP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easons for intervention </a:t>
                      </a:r>
                      <a:endParaRPr lang="en-US" altLang="ja-JP" sz="1200" b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HG丸ｺﾞｼｯｸM-PRO" panose="020F06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o.</a:t>
                      </a:r>
                      <a:r>
                        <a:rPr lang="ja-JP" altLang="en-US" sz="12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n-US" altLang="ja-JP" sz="12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f</a:t>
                      </a:r>
                      <a:r>
                        <a:rPr lang="ja-JP" altLang="en-US" sz="12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n-US" altLang="ja-JP" sz="12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ach reason for intervention</a:t>
                      </a:r>
                      <a:r>
                        <a:rPr lang="en-US" altLang="ja-JP" sz="1200" u="none" strike="noStrike" baseline="300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* </a:t>
                      </a:r>
                      <a:r>
                        <a:rPr lang="en-US" altLang="ja-JP" sz="1200" u="none" strike="noStrike" baseline="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%)</a:t>
                      </a:r>
                    </a:p>
                    <a:p>
                      <a:pPr algn="ctr" fontAlgn="ctr"/>
                      <a:r>
                        <a:rPr lang="en-US" altLang="ja-JP" sz="1200" b="0" i="0" u="none" strike="noStrike" baseline="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HG丸ｺﾞｼｯｸM-PRO" panose="020F0600000000000000" pitchFamily="50" charset="-128"/>
                          <a:cs typeface="Times New Roman" panose="02020603050405020304" pitchFamily="18" charset="0"/>
                        </a:rPr>
                        <a:t>n = 192</a:t>
                      </a:r>
                      <a:endParaRPr lang="ja-JP" altLang="en-US" sz="1200" b="0" i="0" u="none" strike="noStrike" baseline="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HG丸ｺﾞｼｯｸM-PRO" panose="020F06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2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dherence rate </a:t>
                      </a:r>
                      <a:endParaRPr lang="ja-JP" altLang="en-US" sz="1200" b="1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HG丸ｺﾞｼｯｸM-PRO" panose="020F06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/>
                </a:tc>
                <a:extLst>
                  <a:ext uri="{0D108BD9-81ED-4DB2-BD59-A6C34878D82A}">
                    <a16:rowId xmlns:a16="http://schemas.microsoft.com/office/drawing/2014/main" val="1006269419"/>
                  </a:ext>
                </a:extLst>
              </a:tr>
              <a:tr h="438158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e-escalation</a:t>
                      </a:r>
                      <a:endParaRPr 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HG丸ｺﾞｼｯｸM-PRO" panose="020F06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1 (16.1%)</a:t>
                      </a:r>
                      <a:endParaRPr lang="en-US" altLang="ja-JP" sz="12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HG丸ｺﾞｼｯｸM-PRO" panose="020F06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8/31 (90.3%)</a:t>
                      </a:r>
                      <a:endParaRPr lang="en-US" altLang="ja-JP" sz="12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HG丸ｺﾞｼｯｸM-PRO" panose="020F06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/>
                </a:tc>
                <a:extLst>
                  <a:ext uri="{0D108BD9-81ED-4DB2-BD59-A6C34878D82A}">
                    <a16:rowId xmlns:a16="http://schemas.microsoft.com/office/drawing/2014/main" val="4071695774"/>
                  </a:ext>
                </a:extLst>
              </a:tr>
              <a:tr h="438158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ntravenous to oral stepdown</a:t>
                      </a:r>
                      <a:endParaRPr 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HG丸ｺﾞｼｯｸM-PRO" panose="020F06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HG丸ｺﾞｼｯｸM-PRO" panose="020F0600000000000000" pitchFamily="50" charset="-128"/>
                          <a:cs typeface="Times New Roman" panose="02020603050405020304" pitchFamily="18" charset="0"/>
                        </a:rPr>
                        <a:t>30 (15.6%)</a:t>
                      </a: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HG丸ｺﾞｼｯｸM-PRO" panose="020F0600000000000000" pitchFamily="50" charset="-128"/>
                          <a:cs typeface="Times New Roman" panose="02020603050405020304" pitchFamily="18" charset="0"/>
                        </a:rPr>
                        <a:t>27/30 (90.0%)</a:t>
                      </a:r>
                    </a:p>
                  </a:txBody>
                  <a:tcPr marL="7620" marR="7620" marT="7620" marB="0" anchor="ctr"/>
                </a:tc>
                <a:extLst>
                  <a:ext uri="{0D108BD9-81ED-4DB2-BD59-A6C34878D82A}">
                    <a16:rowId xmlns:a16="http://schemas.microsoft.com/office/drawing/2014/main" val="1826716221"/>
                  </a:ext>
                </a:extLst>
              </a:tr>
              <a:tr h="438158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lteration of antibiotics for other reasons</a:t>
                      </a:r>
                      <a:endParaRPr lang="ja-JP" alt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HG丸ｺﾞｼｯｸM-PRO" panose="020F06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HG丸ｺﾞｼｯｸM-PRO" panose="020F0600000000000000" pitchFamily="50" charset="-128"/>
                          <a:cs typeface="Times New Roman" panose="02020603050405020304" pitchFamily="18" charset="0"/>
                        </a:rPr>
                        <a:t>77 (40.1%)</a:t>
                      </a: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HG丸ｺﾞｼｯｸM-PRO" panose="020F0600000000000000" pitchFamily="50" charset="-128"/>
                          <a:cs typeface="Times New Roman" panose="02020603050405020304" pitchFamily="18" charset="0"/>
                        </a:rPr>
                        <a:t>69/77 (89.6%)</a:t>
                      </a:r>
                    </a:p>
                  </a:txBody>
                  <a:tcPr marL="7620" marR="7620" marT="7620" marB="0" anchor="ctr"/>
                </a:tc>
                <a:extLst>
                  <a:ext uri="{0D108BD9-81ED-4DB2-BD59-A6C34878D82A}">
                    <a16:rowId xmlns:a16="http://schemas.microsoft.com/office/drawing/2014/main" val="3624973751"/>
                  </a:ext>
                </a:extLst>
              </a:tr>
              <a:tr h="438158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ose optimization</a:t>
                      </a:r>
                      <a:endParaRPr lang="ja-JP" alt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HG丸ｺﾞｼｯｸM-PRO" panose="020F06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HG丸ｺﾞｼｯｸM-PRO" panose="020F0600000000000000" pitchFamily="50" charset="-128"/>
                          <a:cs typeface="Times New Roman" panose="02020603050405020304" pitchFamily="18" charset="0"/>
                        </a:rPr>
                        <a:t>21 (10.9%)</a:t>
                      </a: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HG丸ｺﾞｼｯｸM-PRO" panose="020F0600000000000000" pitchFamily="50" charset="-128"/>
                          <a:cs typeface="Times New Roman" panose="02020603050405020304" pitchFamily="18" charset="0"/>
                        </a:rPr>
                        <a:t>20/21 (95.2%)</a:t>
                      </a:r>
                    </a:p>
                  </a:txBody>
                  <a:tcPr marL="7620" marR="7620" marT="7620" marB="0" anchor="ctr"/>
                </a:tc>
                <a:extLst>
                  <a:ext uri="{0D108BD9-81ED-4DB2-BD59-A6C34878D82A}">
                    <a16:rowId xmlns:a16="http://schemas.microsoft.com/office/drawing/2014/main" val="2943854664"/>
                  </a:ext>
                </a:extLst>
              </a:tr>
              <a:tr h="438158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TW" sz="12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dherence to recommended duration of antibiotic use in the guidelines</a:t>
                      </a:r>
                      <a:endParaRPr lang="zh-TW" alt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HG丸ｺﾞｼｯｸM-PRO" panose="020F06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HG丸ｺﾞｼｯｸM-PRO" panose="020F0600000000000000" pitchFamily="50" charset="-128"/>
                          <a:cs typeface="Times New Roman" panose="02020603050405020304" pitchFamily="18" charset="0"/>
                        </a:rPr>
                        <a:t>24 (12.5%)</a:t>
                      </a: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HG丸ｺﾞｼｯｸM-PRO" panose="020F0600000000000000" pitchFamily="50" charset="-128"/>
                          <a:cs typeface="Times New Roman" panose="02020603050405020304" pitchFamily="18" charset="0"/>
                        </a:rPr>
                        <a:t>21/24 (87.5%)</a:t>
                      </a:r>
                    </a:p>
                  </a:txBody>
                  <a:tcPr marL="7620" marR="7620" marT="7620" marB="0" anchor="ctr"/>
                </a:tc>
                <a:extLst>
                  <a:ext uri="{0D108BD9-81ED-4DB2-BD59-A6C34878D82A}">
                    <a16:rowId xmlns:a16="http://schemas.microsoft.com/office/drawing/2014/main" val="1437294190"/>
                  </a:ext>
                </a:extLst>
              </a:tr>
              <a:tr h="438158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iscontinuation of antibiotics in patients with prolonged use or noninfectious conditions</a:t>
                      </a:r>
                      <a:endParaRPr lang="ja-JP" alt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HG丸ｺﾞｼｯｸM-PRO" panose="020F06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HG丸ｺﾞｼｯｸM-PRO" panose="020F0600000000000000" pitchFamily="50" charset="-128"/>
                          <a:cs typeface="Times New Roman" panose="02020603050405020304" pitchFamily="18" charset="0"/>
                        </a:rPr>
                        <a:t>107 (55.7%)</a:t>
                      </a: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HG丸ｺﾞｼｯｸM-PRO" panose="020F0600000000000000" pitchFamily="50" charset="-128"/>
                          <a:cs typeface="Times New Roman" panose="02020603050405020304" pitchFamily="18" charset="0"/>
                        </a:rPr>
                        <a:t>93/107 (86.9%)</a:t>
                      </a:r>
                    </a:p>
                  </a:txBody>
                  <a:tcPr marL="7620" marR="7620" marT="7620" marB="0" anchor="ctr"/>
                </a:tc>
                <a:extLst>
                  <a:ext uri="{0D108BD9-81ED-4DB2-BD59-A6C34878D82A}">
                    <a16:rowId xmlns:a16="http://schemas.microsoft.com/office/drawing/2014/main" val="2871509826"/>
                  </a:ext>
                </a:extLst>
              </a:tr>
              <a:tr h="438158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herapeutic drug monitoring</a:t>
                      </a:r>
                      <a:endParaRPr 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HG丸ｺﾞｼｯｸM-PRO" panose="020F06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HG丸ｺﾞｼｯｸM-PRO" panose="020F0600000000000000" pitchFamily="50" charset="-128"/>
                          <a:cs typeface="Times New Roman" panose="02020603050405020304" pitchFamily="18" charset="0"/>
                        </a:rPr>
                        <a:t>34 (17.1%)</a:t>
                      </a: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HG丸ｺﾞｼｯｸM-PRO" panose="020F0600000000000000" pitchFamily="50" charset="-128"/>
                          <a:cs typeface="Times New Roman" panose="02020603050405020304" pitchFamily="18" charset="0"/>
                        </a:rPr>
                        <a:t>34/34 (100%)</a:t>
                      </a:r>
                    </a:p>
                  </a:txBody>
                  <a:tcPr marL="7620" marR="7620" marT="7620" marB="0" anchor="ctr"/>
                </a:tc>
                <a:extLst>
                  <a:ext uri="{0D108BD9-81ED-4DB2-BD59-A6C34878D82A}">
                    <a16:rowId xmlns:a16="http://schemas.microsoft.com/office/drawing/2014/main" val="3625880575"/>
                  </a:ext>
                </a:extLst>
              </a:tr>
              <a:tr h="438158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ther </a:t>
                      </a:r>
                      <a:endParaRPr 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HG丸ｺﾞｼｯｸM-PRO" panose="020F06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HG丸ｺﾞｼｯｸM-PRO" panose="020F0600000000000000" pitchFamily="50" charset="-128"/>
                          <a:cs typeface="Times New Roman" panose="02020603050405020304" pitchFamily="18" charset="0"/>
                        </a:rPr>
                        <a:t>20 (10.4%)</a:t>
                      </a: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HG丸ｺﾞｼｯｸM-PRO" panose="020F0600000000000000" pitchFamily="50" charset="-128"/>
                          <a:cs typeface="Times New Roman" panose="02020603050405020304" pitchFamily="18" charset="0"/>
                        </a:rPr>
                        <a:t>14/20 (70.0%)</a:t>
                      </a:r>
                    </a:p>
                  </a:txBody>
                  <a:tcPr marL="7620" marR="7620" marT="7620" marB="0" anchor="ctr"/>
                </a:tc>
                <a:extLst>
                  <a:ext uri="{0D108BD9-81ED-4DB2-BD59-A6C34878D82A}">
                    <a16:rowId xmlns:a16="http://schemas.microsoft.com/office/drawing/2014/main" val="2242619733"/>
                  </a:ext>
                </a:extLst>
              </a:tr>
            </a:tbl>
          </a:graphicData>
        </a:graphic>
      </p:graphicFrame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55EFC036-7620-4546-B907-0434383B4CCB}"/>
              </a:ext>
            </a:extLst>
          </p:cNvPr>
          <p:cNvSpPr txBox="1"/>
          <p:nvPr/>
        </p:nvSpPr>
        <p:spPr>
          <a:xfrm>
            <a:off x="1378834" y="5541876"/>
            <a:ext cx="393569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*</a:t>
            </a:r>
            <a:r>
              <a:rPr lang="hu-HU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ore than one reason can apply for each intervened event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  <a:endParaRPr kumimoji="1" lang="en-US" altLang="ja-JP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58588834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6330</TotalTime>
  <Words>218</Words>
  <Application>Microsoft Office PowerPoint</Application>
  <PresentationFormat>ワイド画面</PresentationFormat>
  <Paragraphs>33</Paragraphs>
  <Slides>1</Slides>
  <Notes>1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6" baseType="lpstr">
      <vt:lpstr>游ゴシック</vt:lpstr>
      <vt:lpstr>游ゴシック Light</vt:lpstr>
      <vt:lpstr>Arial</vt:lpstr>
      <vt:lpstr>Times New Roman</vt:lpstr>
      <vt:lpstr>Office テーマ</vt:lpstr>
      <vt:lpstr>S5 Table. Reasons for intervention by antimicrobial stewardship team and adherence rate by physicians between April 2022 and September 2022.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SE_Mente</dc:creator>
  <cp:lastModifiedBy>植田貴史</cp:lastModifiedBy>
  <cp:revision>312</cp:revision>
  <cp:lastPrinted>2023-04-12T10:42:11Z</cp:lastPrinted>
  <dcterms:created xsi:type="dcterms:W3CDTF">2022-09-14T02:01:21Z</dcterms:created>
  <dcterms:modified xsi:type="dcterms:W3CDTF">2023-04-12T10:44:44Z</dcterms:modified>
</cp:coreProperties>
</file>